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416"/>
    <p:restoredTop sz="94688"/>
  </p:normalViewPr>
  <p:slideViewPr>
    <p:cSldViewPr snapToGrid="0" snapToObjects="1">
      <p:cViewPr varScale="1">
        <p:scale>
          <a:sx n="116" d="100"/>
          <a:sy n="116" d="100"/>
        </p:scale>
        <p:origin x="59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B756A9-57CD-4249-8327-0E56F53FD6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F7F5A9E-7772-3646-8BEF-68E1F08AE1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8D44AD1-B9F6-A946-8761-5ECB562B5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F2633-BE3D-4548-82A7-49A9C489DE41}" type="datetimeFigureOut">
              <a:rPr kumimoji="1" lang="zh-CN" altLang="en-US" smtClean="0"/>
              <a:t>2025/2/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1D47F4C-9806-4045-A61B-58765BCD47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C19478F-23A2-DA46-9589-97E48AE175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39DC5-E0A0-C946-96E0-048DFFF44CC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90696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6CFB12A-738B-9841-8556-E4006AE411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240AEB8-4C1C-F247-8E07-B563D45120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4EFCF56-248A-A942-AF28-A5726909A8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F2633-BE3D-4548-82A7-49A9C489DE41}" type="datetimeFigureOut">
              <a:rPr kumimoji="1" lang="zh-CN" altLang="en-US" smtClean="0"/>
              <a:t>2025/2/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8BB88D0-982B-9347-BD2E-774600ABD5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F1CB8B-BD42-9542-B94C-B58E4B4DA9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39DC5-E0A0-C946-96E0-048DFFF44CC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95169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AD6B571-F45F-0B40-9173-D0B8A406DC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8B0623A-3395-314D-9098-50F7D9E275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1B99C68-CF93-B447-A778-92FB6607D4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F2633-BE3D-4548-82A7-49A9C489DE41}" type="datetimeFigureOut">
              <a:rPr kumimoji="1" lang="zh-CN" altLang="en-US" smtClean="0"/>
              <a:t>2025/2/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B46FA61-647A-DC4A-9ABE-D733D9865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ACB8BDE-3FA5-2545-9999-E848494FA6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39DC5-E0A0-C946-96E0-048DFFF44CC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82947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4DD6AF-3CA9-504A-9D6D-793B7D6A62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937A34D-9718-954D-9720-2A199AA611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182592A-6119-AB46-8050-AD2AA43DDD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F2633-BE3D-4548-82A7-49A9C489DE41}" type="datetimeFigureOut">
              <a:rPr kumimoji="1" lang="zh-CN" altLang="en-US" smtClean="0"/>
              <a:t>2025/2/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5662251-D625-6D4B-8323-83FF6BE50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025C6E-A1EA-4C48-BE59-2F30F5996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39DC5-E0A0-C946-96E0-048DFFF44CC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3772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117FD9-DF1B-C946-946C-1BF622A8C0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CE7BA4D-D462-9E49-BED2-A334421402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C332021-3B1F-E149-B841-83A2AD50DD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F2633-BE3D-4548-82A7-49A9C489DE41}" type="datetimeFigureOut">
              <a:rPr kumimoji="1" lang="zh-CN" altLang="en-US" smtClean="0"/>
              <a:t>2025/2/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A4B0173-8BED-CA41-8804-754DFA362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6101160-3E4F-014B-9C09-25C5A8E52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39DC5-E0A0-C946-96E0-048DFFF44CC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52391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8C9AED-F9DF-7E48-B17D-71C636E9E2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B4F2E6A-70FA-784D-9835-6706D27ACE1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A1A5765-AC21-CA46-AA21-6C99BF0A8F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1B0AED8-8AD3-654A-96B3-65FD517E8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F2633-BE3D-4548-82A7-49A9C489DE41}" type="datetimeFigureOut">
              <a:rPr kumimoji="1" lang="zh-CN" altLang="en-US" smtClean="0"/>
              <a:t>2025/2/9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1062294-7FE6-4042-9B9F-2D5E84A17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531C67B-FC57-2C4C-8F3D-C3ED18F37C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39DC5-E0A0-C946-96E0-048DFFF44CC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33459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1343A2-1310-BE47-A6F6-7CA2652D75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176FD3B-698E-1840-A280-3356934C9A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9424580-562F-F349-83A7-1CCF1E5121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A1C0038-808B-0D46-8614-CC1F26E476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6C2EA06-C603-754A-84A6-0120098769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9987CA8-BD48-A245-A153-DBE3EEF95E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F2633-BE3D-4548-82A7-49A9C489DE41}" type="datetimeFigureOut">
              <a:rPr kumimoji="1" lang="zh-CN" altLang="en-US" smtClean="0"/>
              <a:t>2025/2/9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CF39156-DB29-7D43-B865-A3DCF0B258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337A14F-58B5-2B4D-B434-066C4A02DB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39DC5-E0A0-C946-96E0-048DFFF44CC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028936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2A1366-7BAD-E84F-8B98-AEDEC77A39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1D4D039-614A-324E-8F0C-0C9BFE3244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F2633-BE3D-4548-82A7-49A9C489DE41}" type="datetimeFigureOut">
              <a:rPr kumimoji="1" lang="zh-CN" altLang="en-US" smtClean="0"/>
              <a:t>2025/2/9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0D58369-640C-4B48-BB64-0ABAB1433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FDE015A-9CDD-5841-B28C-0C16FC18ED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39DC5-E0A0-C946-96E0-048DFFF44CC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633763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D4DDA27-24D6-254D-885C-6DC76F1BED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F2633-BE3D-4548-82A7-49A9C489DE41}" type="datetimeFigureOut">
              <a:rPr kumimoji="1" lang="zh-CN" altLang="en-US" smtClean="0"/>
              <a:t>2025/2/9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5C0AFED-ACEB-4042-957C-89CA71419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E15DFEF-3557-3A4E-B98A-378FA25A28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39DC5-E0A0-C946-96E0-048DFFF44CC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82397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29B528-D837-C54C-9082-532E850582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48ED476-FD7A-C14D-9004-48060D9254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7D62F2A-082B-1E40-869F-F671622FAB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CB9C97C-CBEC-A84F-A6BC-2194C2D5CE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F2633-BE3D-4548-82A7-49A9C489DE41}" type="datetimeFigureOut">
              <a:rPr kumimoji="1" lang="zh-CN" altLang="en-US" smtClean="0"/>
              <a:t>2025/2/9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D3B8034-1FD9-0344-B790-ED10F02E54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E36CE7A-57E0-FB42-8F20-F1A9083D9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39DC5-E0A0-C946-96E0-048DFFF44CC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19558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DA5CC2-FFFA-3040-BA59-3EB6504F42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DD5DE59-46FC-DC4E-BAD0-E8BDC529237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87EA38A-C904-E94A-8998-6EC2CC550C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6DCAD94-FF47-B749-95B0-8470FD666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F2633-BE3D-4548-82A7-49A9C489DE41}" type="datetimeFigureOut">
              <a:rPr kumimoji="1" lang="zh-CN" altLang="en-US" smtClean="0"/>
              <a:t>2025/2/9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65C5E6C-3B0F-384C-88EB-DA03365FE6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4DA3C6D-4E9E-B543-90E7-278E1A665A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39DC5-E0A0-C946-96E0-048DFFF44CC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21864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195BD3E-910C-B742-B189-41243C097E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7D18F62-BE16-BA40-9706-B0DF73CBBC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423B117-4F4C-7642-B309-12003E52EF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6F2633-BE3D-4548-82A7-49A9C489DE41}" type="datetimeFigureOut">
              <a:rPr kumimoji="1" lang="zh-CN" altLang="en-US" smtClean="0"/>
              <a:t>2025/2/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C7C1144-EC60-A442-87FD-7354DE72FB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F2149AC-F915-B84E-BDB3-A80081EEFA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39DC5-E0A0-C946-96E0-048DFFF44CC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83374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4A1B2C5D-FF39-FE4F-9883-EE3B051A2E8E}"/>
              </a:ext>
            </a:extLst>
          </p:cNvPr>
          <p:cNvSpPr txBox="1"/>
          <p:nvPr/>
        </p:nvSpPr>
        <p:spPr>
          <a:xfrm>
            <a:off x="1173269" y="5993692"/>
            <a:ext cx="1045574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spcBef>
                <a:spcPts val="1200"/>
              </a:spcBef>
              <a:spcAft>
                <a:spcPts val="1200"/>
              </a:spcAft>
            </a:pP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1. </a:t>
            </a:r>
            <a:r>
              <a:rPr lang="sv-SE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land-Altman plots for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ntra</a:t>
            </a:r>
            <a:r>
              <a:rPr lang="sv-SE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bserver variability.</a:t>
            </a:r>
            <a:endParaRPr lang="zh-CN" altLang="en-US" sz="12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C9223A0B-DD51-984F-8204-869CA7C9A0BC}"/>
              </a:ext>
            </a:extLst>
          </p:cNvPr>
          <p:cNvGrpSpPr/>
          <p:nvPr/>
        </p:nvGrpSpPr>
        <p:grpSpPr>
          <a:xfrm>
            <a:off x="855629" y="628261"/>
            <a:ext cx="10480742" cy="4784591"/>
            <a:chOff x="381497" y="804531"/>
            <a:chExt cx="10480742" cy="4784591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E71569FD-8B99-9A46-A12A-8E4A1107252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497" y="804531"/>
              <a:ext cx="2594357" cy="2338852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0BBCD6DF-83B0-B746-8297-4B5CEEDCF37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10292" y="808693"/>
              <a:ext cx="2594357" cy="2338852"/>
            </a:xfrm>
            <a:prstGeom prst="rect">
              <a:avLst/>
            </a:prstGeom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A905C054-928B-A04C-83ED-53F0537A93A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637572" y="804531"/>
              <a:ext cx="2594357" cy="2338852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8F869D6F-1B4F-DC42-8D2D-C7A6E3E4600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267882" y="804531"/>
              <a:ext cx="2594357" cy="2338852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3BFA04FF-FC56-7A44-8A44-34C2E33BDE3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1497" y="3250270"/>
              <a:ext cx="2594357" cy="2338852"/>
            </a:xfrm>
            <a:prstGeom prst="rect">
              <a:avLst/>
            </a:prstGeom>
          </p:spPr>
        </p:pic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371F6A2B-0029-334A-9ECB-E040370AE37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975854" y="3250270"/>
              <a:ext cx="2594357" cy="2338852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0072CAAF-2470-C244-A7A2-B8018803FB1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604649" y="3246108"/>
              <a:ext cx="2594357" cy="2338852"/>
            </a:xfrm>
            <a:prstGeom prst="rect">
              <a:avLst/>
            </a:prstGeom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0532ACAD-B00C-734A-B1C0-5BE8759F1DBB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8267882" y="3246108"/>
              <a:ext cx="2594357" cy="23388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989684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2C729481-18B9-F745-8113-DBE9BB177E0F}"/>
              </a:ext>
            </a:extLst>
          </p:cNvPr>
          <p:cNvSpPr txBox="1"/>
          <p:nvPr/>
        </p:nvSpPr>
        <p:spPr>
          <a:xfrm>
            <a:off x="1110924" y="6107004"/>
            <a:ext cx="1045574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spcBef>
                <a:spcPts val="1200"/>
              </a:spcBef>
              <a:spcAft>
                <a:spcPts val="1200"/>
              </a:spcAft>
            </a:pP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2. </a:t>
            </a:r>
            <a:r>
              <a:rPr lang="sv-SE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land-Altman plots for interobserver variability.</a:t>
            </a:r>
            <a:endParaRPr lang="zh-CN" altLang="en-US" sz="12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7528D933-A6C6-6E4F-8A92-9A0F4C5024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9638" y="3065442"/>
            <a:ext cx="2595600" cy="2339973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2AC60159-F0C3-D24A-9F3B-A225829938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55778" y="720034"/>
            <a:ext cx="2595600" cy="2339973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02F4AB0B-E2DA-7D4E-A93F-BFC048CD93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85508" y="730905"/>
            <a:ext cx="2595600" cy="2339973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AB31F59A-2459-A547-A39A-5B4617A02D0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52573" y="720035"/>
            <a:ext cx="2595600" cy="2339973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5ABC69CC-FCB3-E541-8DBE-64A2F3A37BC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9638" y="725469"/>
            <a:ext cx="2595600" cy="2339973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0BBDBA0C-A552-404F-B629-63B7914E84D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618443" y="3065442"/>
            <a:ext cx="2595600" cy="2339973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232BBCE8-6AA9-EB45-9C20-9E3BBAF9A5D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885508" y="3070878"/>
            <a:ext cx="2595600" cy="2339973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1DE3B6E6-840E-EA43-9F39-D88EEC25404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152573" y="3070878"/>
            <a:ext cx="2595600" cy="23399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6842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1</Words>
  <Application>Microsoft Macintosh PowerPoint</Application>
  <PresentationFormat>宽屏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angjihyun</dc:creator>
  <cp:lastModifiedBy>Maangjihyun</cp:lastModifiedBy>
  <cp:revision>1</cp:revision>
  <dcterms:created xsi:type="dcterms:W3CDTF">2025-02-09T14:37:43Z</dcterms:created>
  <dcterms:modified xsi:type="dcterms:W3CDTF">2025-02-09T14:44:56Z</dcterms:modified>
</cp:coreProperties>
</file>